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59" autoAdjust="0"/>
    <p:restoredTop sz="94660"/>
  </p:normalViewPr>
  <p:slideViewPr>
    <p:cSldViewPr snapToGrid="0" showGuides="1">
      <p:cViewPr varScale="1">
        <p:scale>
          <a:sx n="117" d="100"/>
          <a:sy n="117" d="100"/>
        </p:scale>
        <p:origin x="-156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647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6522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4062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1097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1516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320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94334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422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7201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8592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7383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8942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52450" y="323850"/>
            <a:ext cx="40386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1 Table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965442" y="323850"/>
            <a:ext cx="5060715" cy="365358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64012967-0F81-4311-8313-DAB5C6A94754}"/>
              </a:ext>
            </a:extLst>
          </p:cNvPr>
          <p:cNvSpPr txBox="1"/>
          <p:nvPr/>
        </p:nvSpPr>
        <p:spPr>
          <a:xfrm>
            <a:off x="445477" y="4285753"/>
            <a:ext cx="833974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VLTGVVGGETQNNEERQNEPSGFLRFLTYLYKS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VRINSLIIQNQAFAEMTNIFNWDYFTD</a:t>
            </a:r>
            <a:r>
              <a:rPr lang="en-GB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MDMYNHWVNQDEYNPPKDSEFYERFW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ELDRRGDLHFIEKEGDHLQINSEWFVNNIVIPF</a:t>
            </a:r>
            <a:r>
              <a:rPr lang="en-GB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ITKNKFFIKNFTIRGAPFDFRKLPNENIHFMDKLKLLVEETYTN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KRYPMPIPHPPVYFQEPTFSFENFTFT Mw 23252 Da</a:t>
            </a:r>
          </a:p>
          <a:p>
            <a:endParaRPr lang="en-GB" sz="1200" dirty="0" smtClean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2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EG-12, </a:t>
            </a:r>
            <a:r>
              <a:rPr lang="en-GB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SP PROT, </a:t>
            </a:r>
            <a:r>
              <a:rPr lang="en-GB" sz="12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EG-8.3, </a:t>
            </a:r>
            <a:r>
              <a:rPr lang="en-GB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TE, </a:t>
            </a:r>
            <a:r>
              <a:rPr lang="en-GB" sz="12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LA A #2, </a:t>
            </a:r>
            <a:r>
              <a:rPr lang="en-GB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EG-22</a:t>
            </a:r>
            <a:endParaRPr lang="en-GB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54812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21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Yor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Wilson</dc:creator>
  <cp:lastModifiedBy>Roopavathy</cp:lastModifiedBy>
  <cp:revision>4</cp:revision>
  <dcterms:created xsi:type="dcterms:W3CDTF">2019-08-28T10:03:25Z</dcterms:created>
  <dcterms:modified xsi:type="dcterms:W3CDTF">2020-02-17T06:20:40Z</dcterms:modified>
</cp:coreProperties>
</file>